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280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3360" userDrawn="1">
          <p15:clr>
            <a:srgbClr val="A4A3A4"/>
          </p15:clr>
        </p15:guide>
        <p15:guide id="4" pos="1680" userDrawn="1">
          <p15:clr>
            <a:srgbClr val="A4A3A4"/>
          </p15:clr>
        </p15:guide>
        <p15:guide id="5" orient="horz" pos="336" userDrawn="1">
          <p15:clr>
            <a:srgbClr val="A4A3A4"/>
          </p15:clr>
        </p15:guide>
        <p15:guide id="6" orient="horz" pos="53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9F9F9F"/>
    <a:srgbClr val="C6C5C4"/>
    <a:srgbClr val="8D8C8A"/>
    <a:srgbClr val="525252"/>
    <a:srgbClr val="33CCCC"/>
    <a:srgbClr val="FF0000"/>
    <a:srgbClr val="C00000"/>
    <a:srgbClr val="408697"/>
    <a:srgbClr val="6800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3237A3-C8ED-4FDD-9653-DFB1A4E1C85B}" v="2" dt="2025-06-23T21:29:12.3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51" autoAdjust="0"/>
    <p:restoredTop sz="93447" autoAdjust="0"/>
  </p:normalViewPr>
  <p:slideViewPr>
    <p:cSldViewPr snapToGrid="0">
      <p:cViewPr varScale="1">
        <p:scale>
          <a:sx n="39" d="100"/>
          <a:sy n="39" d="100"/>
        </p:scale>
        <p:origin x="2312" y="260"/>
      </p:cViewPr>
      <p:guideLst>
        <p:guide pos="3360"/>
        <p:guide pos="1680"/>
        <p:guide orient="horz" pos="336"/>
        <p:guide orient="horz" pos="5328"/>
      </p:guideLst>
    </p:cSldViewPr>
  </p:slideViewPr>
  <p:outlineViewPr>
    <p:cViewPr>
      <p:scale>
        <a:sx n="33" d="100"/>
        <a:sy n="33" d="100"/>
      </p:scale>
      <p:origin x="0" y="-7419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74" d="100"/>
        <a:sy n="74" d="100"/>
      </p:scale>
      <p:origin x="0" y="0"/>
    </p:cViewPr>
  </p:sorterViewPr>
  <p:gridSpacing cx="182880" cy="18288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eike Schell" userId="+hwTHCJ9DPY+RcXtlOoxeiHCh/r8M9NERwcOBswqpyo=" providerId="None" clId="Web-{D0E174A4-FF77-410E-A064-A65E48C01CE0}"/>
    <pc:docChg chg="addSld modSld">
      <pc:chgData name="Mareike Schell" userId="+hwTHCJ9DPY+RcXtlOoxeiHCh/r8M9NERwcOBswqpyo=" providerId="None" clId="Web-{D0E174A4-FF77-410E-A064-A65E48C01CE0}" dt="2025-06-18T20:38:09.875" v="6"/>
      <pc:docMkLst>
        <pc:docMk/>
      </pc:docMkLst>
      <pc:sldChg chg="delSp">
        <pc:chgData name="Mareike Schell" userId="+hwTHCJ9DPY+RcXtlOoxeiHCh/r8M9NERwcOBswqpyo=" providerId="None" clId="Web-{D0E174A4-FF77-410E-A064-A65E48C01CE0}" dt="2025-06-18T20:38:07.875" v="5"/>
        <pc:sldMkLst>
          <pc:docMk/>
          <pc:sldMk cId="1691594351" sldId="2270"/>
        </pc:sldMkLst>
        <pc:spChg chg="del">
          <ac:chgData name="Mareike Schell" userId="+hwTHCJ9DPY+RcXtlOoxeiHCh/r8M9NERwcOBswqpyo=" providerId="None" clId="Web-{D0E174A4-FF77-410E-A064-A65E48C01CE0}" dt="2025-06-18T20:38:07.875" v="5"/>
          <ac:spMkLst>
            <pc:docMk/>
            <pc:sldMk cId="1691594351" sldId="2270"/>
            <ac:spMk id="4" creationId="{1EB32637-4065-5203-92A6-816C76BE9F93}"/>
          </ac:spMkLst>
        </pc:spChg>
        <pc:spChg chg="del">
          <ac:chgData name="Mareike Schell" userId="+hwTHCJ9DPY+RcXtlOoxeiHCh/r8M9NERwcOBswqpyo=" providerId="None" clId="Web-{D0E174A4-FF77-410E-A064-A65E48C01CE0}" dt="2025-06-18T20:38:07.875" v="4"/>
          <ac:spMkLst>
            <pc:docMk/>
            <pc:sldMk cId="1691594351" sldId="2270"/>
            <ac:spMk id="6" creationId="{2F9575D5-9BCF-EE54-D239-C7BA39B5210C}"/>
          </ac:spMkLst>
        </pc:spChg>
        <pc:spChg chg="del">
          <ac:chgData name="Mareike Schell" userId="+hwTHCJ9DPY+RcXtlOoxeiHCh/r8M9NERwcOBswqpyo=" providerId="None" clId="Web-{D0E174A4-FF77-410E-A064-A65E48C01CE0}" dt="2025-06-18T20:38:07.875" v="3"/>
          <ac:spMkLst>
            <pc:docMk/>
            <pc:sldMk cId="1691594351" sldId="2270"/>
            <ac:spMk id="7" creationId="{7713419C-40F1-166F-7685-12DD873E3889}"/>
          </ac:spMkLst>
        </pc:spChg>
        <pc:spChg chg="del">
          <ac:chgData name="Mareike Schell" userId="+hwTHCJ9DPY+RcXtlOoxeiHCh/r8M9NERwcOBswqpyo=" providerId="None" clId="Web-{D0E174A4-FF77-410E-A064-A65E48C01CE0}" dt="2025-06-18T20:38:07.875" v="2"/>
          <ac:spMkLst>
            <pc:docMk/>
            <pc:sldMk cId="1691594351" sldId="2270"/>
            <ac:spMk id="8" creationId="{5D6FC1C1-F155-861D-A7A1-E2651E6E9C66}"/>
          </ac:spMkLst>
        </pc:spChg>
        <pc:grpChg chg="del">
          <ac:chgData name="Mareike Schell" userId="+hwTHCJ9DPY+RcXtlOoxeiHCh/r8M9NERwcOBswqpyo=" providerId="None" clId="Web-{D0E174A4-FF77-410E-A064-A65E48C01CE0}" dt="2025-06-18T20:38:07.859" v="1"/>
          <ac:grpSpMkLst>
            <pc:docMk/>
            <pc:sldMk cId="1691594351" sldId="2270"/>
            <ac:grpSpMk id="9" creationId="{CC359C9F-7BC9-47CF-BEFC-0DA61A45203F}"/>
          </ac:grpSpMkLst>
        </pc:grpChg>
      </pc:sldChg>
      <pc:sldChg chg="addSp new">
        <pc:chgData name="Mareike Schell" userId="+hwTHCJ9DPY+RcXtlOoxeiHCh/r8M9NERwcOBswqpyo=" providerId="None" clId="Web-{D0E174A4-FF77-410E-A064-A65E48C01CE0}" dt="2025-06-18T20:38:09.875" v="6"/>
        <pc:sldMkLst>
          <pc:docMk/>
          <pc:sldMk cId="2105458467" sldId="2283"/>
        </pc:sldMkLst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4" creationId="{7713419C-40F1-166F-7685-12DD873E3889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9" creationId="{E33C9E2D-3BA5-16D6-C965-E9A2AD306141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0" creationId="{9BC17AB2-4076-8BD3-A3E3-58C3B64B6488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1" creationId="{8C21F97A-DCFA-6FE3-FC8F-60F295899015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4" creationId="{B7B2A7CA-C92B-A038-8147-A0958F7DCF6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0" creationId="{618AA4CC-3E26-D8A3-AC7A-15E7738EF09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1" creationId="{78CEB8C7-CC3D-BB06-5B57-E3A826AC8C92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3" creationId="{A42A442F-B98B-706D-6B50-F9D813670D0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4" creationId="{E16C5DE1-F2ED-1EB1-FF6C-08C5706DA404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8" creationId="{EE79737A-C9DC-B00F-B02E-DD9960F96B8E}"/>
          </ac:spMkLst>
        </pc:spChg>
      </pc:sldChg>
    </pc:docChg>
  </pc:docChgLst>
  <pc:docChgLst>
    <pc:chgData name="Mareike Schell" userId="+hwTHCJ9DPY+RcXtlOoxeiHCh/r8M9NERwcOBswqpyo=" providerId="None" clId="Web-{DB3237A3-C8ED-4FDD-9653-DFB1A4E1C85B}"/>
    <pc:docChg chg="modSld">
      <pc:chgData name="Mareike Schell" userId="+hwTHCJ9DPY+RcXtlOoxeiHCh/r8M9NERwcOBswqpyo=" providerId="None" clId="Web-{DB3237A3-C8ED-4FDD-9653-DFB1A4E1C85B}" dt="2025-06-23T21:29:12.304" v="1" actId="1076"/>
      <pc:docMkLst>
        <pc:docMk/>
      </pc:docMkLst>
      <pc:sldChg chg="modSp">
        <pc:chgData name="Mareike Schell" userId="+hwTHCJ9DPY+RcXtlOoxeiHCh/r8M9NERwcOBswqpyo=" providerId="None" clId="Web-{DB3237A3-C8ED-4FDD-9653-DFB1A4E1C85B}" dt="2025-06-23T21:29:12.304" v="1" actId="1076"/>
        <pc:sldMkLst>
          <pc:docMk/>
          <pc:sldMk cId="957714345" sldId="2282"/>
        </pc:sldMkLst>
        <pc:spChg chg="mod">
          <ac:chgData name="Mareike Schell" userId="+hwTHCJ9DPY+RcXtlOoxeiHCh/r8M9NERwcOBswqpyo=" providerId="None" clId="Web-{DB3237A3-C8ED-4FDD-9653-DFB1A4E1C85B}" dt="2025-06-23T21:29:12.304" v="1" actId="1076"/>
          <ac:spMkLst>
            <pc:docMk/>
            <pc:sldMk cId="957714345" sldId="2282"/>
            <ac:spMk id="406" creationId="{944DE7CF-CC9C-B0F5-5AB0-2468A2E26644}"/>
          </ac:spMkLst>
        </pc:spChg>
      </pc:sldChg>
    </pc:docChg>
  </pc:docChgLst>
  <pc:docChgLst>
    <pc:chgData name="Mareike Schell" userId="+hwTHCJ9DPY+RcXtlOoxeiHCh/r8M9NERwcOBswqpyo=" providerId="None" clId="Web-{92842568-ACA6-4FF0-B290-0595DDCEF770}"/>
    <pc:docChg chg="modSld">
      <pc:chgData name="Mareike Schell" userId="+hwTHCJ9DPY+RcXtlOoxeiHCh/r8M9NERwcOBswqpyo=" providerId="None" clId="Web-{92842568-ACA6-4FF0-B290-0595DDCEF770}" dt="2025-05-02T22:19:57.215" v="187"/>
      <pc:docMkLst>
        <pc:docMk/>
      </pc:docMkLst>
      <pc:sldChg chg="addSp delSp modSp">
        <pc:chgData name="Mareike Schell" userId="+hwTHCJ9DPY+RcXtlOoxeiHCh/r8M9NERwcOBswqpyo=" providerId="None" clId="Web-{92842568-ACA6-4FF0-B290-0595DDCEF770}" dt="2025-05-02T22:17:23.756" v="140"/>
        <pc:sldMkLst>
          <pc:docMk/>
          <pc:sldMk cId="4273005573" sldId="2276"/>
        </pc:sldMkLst>
        <pc:spChg chg="del mod">
          <ac:chgData name="Mareike Schell" userId="+hwTHCJ9DPY+RcXtlOoxeiHCh/r8M9NERwcOBswqpyo=" providerId="None" clId="Web-{92842568-ACA6-4FF0-B290-0595DDCEF770}" dt="2025-05-02T22:17:23.756" v="138"/>
          <ac:spMkLst>
            <pc:docMk/>
            <pc:sldMk cId="4273005573" sldId="2276"/>
            <ac:spMk id="4" creationId="{7476FED3-6C14-9CA0-7EF0-ADF11E285B26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7"/>
          <ac:spMkLst>
            <pc:docMk/>
            <pc:sldMk cId="4273005573" sldId="2276"/>
            <ac:spMk id="5" creationId="{E3C59D4F-2741-7324-DA74-C21FD86C6C13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6"/>
          <ac:spMkLst>
            <pc:docMk/>
            <pc:sldMk cId="4273005573" sldId="2276"/>
            <ac:spMk id="6" creationId="{CACE87EA-B2AA-CAF5-88EA-9769811A81B9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5"/>
          <ac:spMkLst>
            <pc:docMk/>
            <pc:sldMk cId="4273005573" sldId="2276"/>
            <ac:spMk id="8" creationId="{2D886CBF-BFAA-2E47-805D-35FCA336A757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40"/>
          <ac:spMkLst>
            <pc:docMk/>
            <pc:sldMk cId="4273005573" sldId="2276"/>
            <ac:spMk id="123" creationId="{1C139171-2D45-B7BD-65B7-87213805B36A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9"/>
          <ac:spMkLst>
            <pc:docMk/>
            <pc:sldMk cId="4273005573" sldId="2276"/>
            <ac:spMk id="124" creationId="{74010334-5A8C-8AB3-3B8C-71654DF3E834}"/>
          </ac:spMkLst>
        </pc:spChg>
        <pc:cxnChg chg="add del mod">
          <ac:chgData name="Mareike Schell" userId="+hwTHCJ9DPY+RcXtlOoxeiHCh/r8M9NERwcOBswqpyo=" providerId="None" clId="Web-{92842568-ACA6-4FF0-B290-0595DDCEF770}" dt="2025-05-02T22:14:24.031" v="100"/>
          <ac:cxnSpMkLst>
            <pc:docMk/>
            <pc:sldMk cId="4273005573" sldId="2276"/>
            <ac:cxnSpMk id="2" creationId="{CECF07A4-3230-F0C6-0DE9-4B570FC92AA6}"/>
          </ac:cxnSpMkLst>
        </pc:cxnChg>
      </pc:sldChg>
      <pc:sldChg chg="addSp delSp modSp">
        <pc:chgData name="Mareike Schell" userId="+hwTHCJ9DPY+RcXtlOoxeiHCh/r8M9NERwcOBswqpyo=" providerId="None" clId="Web-{92842568-ACA6-4FF0-B290-0595DDCEF770}" dt="2025-05-02T22:19:57.215" v="187"/>
        <pc:sldMkLst>
          <pc:docMk/>
          <pc:sldMk cId="459051783" sldId="2280"/>
        </pc:sldMkLst>
        <pc:spChg chg="del">
          <ac:chgData name="Mareike Schell" userId="+hwTHCJ9DPY+RcXtlOoxeiHCh/r8M9NERwcOBswqpyo=" providerId="None" clId="Web-{92842568-ACA6-4FF0-B290-0595DDCEF770}" dt="2025-05-02T22:16:59.786" v="132"/>
          <ac:spMkLst>
            <pc:docMk/>
            <pc:sldMk cId="459051783" sldId="2280"/>
            <ac:spMk id="11" creationId="{A8EB7B5A-443C-867C-CA7A-A53CC47CDCB1}"/>
          </ac:spMkLst>
        </pc:spChg>
        <pc:spChg chg="add mod">
          <ac:chgData name="Mareike Schell" userId="+hwTHCJ9DPY+RcXtlOoxeiHCh/r8M9NERwcOBswqpyo=" providerId="None" clId="Web-{92842568-ACA6-4FF0-B290-0595DDCEF770}" dt="2025-05-02T22:18:03.132" v="158" actId="1076"/>
          <ac:spMkLst>
            <pc:docMk/>
            <pc:sldMk cId="459051783" sldId="2280"/>
            <ac:spMk id="12" creationId="{1C139171-2D45-B7BD-65B7-87213805B36A}"/>
          </ac:spMkLst>
        </pc:spChg>
        <pc:spChg chg="add mod">
          <ac:chgData name="Mareike Schell" userId="+hwTHCJ9DPY+RcXtlOoxeiHCh/r8M9NERwcOBswqpyo=" providerId="None" clId="Web-{92842568-ACA6-4FF0-B290-0595DDCEF770}" dt="2025-05-02T22:18:03.164" v="159" actId="1076"/>
          <ac:spMkLst>
            <pc:docMk/>
            <pc:sldMk cId="459051783" sldId="2280"/>
            <ac:spMk id="13" creationId="{74010334-5A8C-8AB3-3B8C-71654DF3E834}"/>
          </ac:spMkLst>
        </pc:spChg>
        <pc:spChg chg="add mod">
          <ac:chgData name="Mareike Schell" userId="+hwTHCJ9DPY+RcXtlOoxeiHCh/r8M9NERwcOBswqpyo=" providerId="None" clId="Web-{92842568-ACA6-4FF0-B290-0595DDCEF770}" dt="2025-05-02T22:19:29.245" v="179" actId="1076"/>
          <ac:spMkLst>
            <pc:docMk/>
            <pc:sldMk cId="459051783" sldId="2280"/>
            <ac:spMk id="14" creationId="{7476FED3-6C14-9CA0-7EF0-ADF11E285B26}"/>
          </ac:spMkLst>
        </pc:spChg>
        <pc:spChg chg="add mod">
          <ac:chgData name="Mareike Schell" userId="+hwTHCJ9DPY+RcXtlOoxeiHCh/r8M9NERwcOBswqpyo=" providerId="None" clId="Web-{92842568-ACA6-4FF0-B290-0595DDCEF770}" dt="2025-05-02T22:18:03.257" v="161" actId="1076"/>
          <ac:spMkLst>
            <pc:docMk/>
            <pc:sldMk cId="459051783" sldId="2280"/>
            <ac:spMk id="23" creationId="{E3C59D4F-2741-7324-DA74-C21FD86C6C13}"/>
          </ac:spMkLst>
        </pc:spChg>
        <pc:spChg chg="add mod">
          <ac:chgData name="Mareike Schell" userId="+hwTHCJ9DPY+RcXtlOoxeiHCh/r8M9NERwcOBswqpyo=" providerId="None" clId="Web-{92842568-ACA6-4FF0-B290-0595DDCEF770}" dt="2025-05-02T22:18:03.289" v="162" actId="1076"/>
          <ac:spMkLst>
            <pc:docMk/>
            <pc:sldMk cId="459051783" sldId="2280"/>
            <ac:spMk id="24" creationId="{CACE87EA-B2AA-CAF5-88EA-9769811A81B9}"/>
          </ac:spMkLst>
        </pc:spChg>
        <pc:spChg chg="add mod">
          <ac:chgData name="Mareike Schell" userId="+hwTHCJ9DPY+RcXtlOoxeiHCh/r8M9NERwcOBswqpyo=" providerId="None" clId="Web-{92842568-ACA6-4FF0-B290-0595DDCEF770}" dt="2025-05-02T22:18:03.320" v="163" actId="1076"/>
          <ac:spMkLst>
            <pc:docMk/>
            <pc:sldMk cId="459051783" sldId="2280"/>
            <ac:spMk id="25" creationId="{2D886CBF-BFAA-2E47-805D-35FCA336A757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28" creationId="{DD7E0284-6262-AE94-F830-FBF0417BEC52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30" creationId="{209BF54C-DFEA-0F7F-5D44-9D598493C30D}"/>
          </ac:spMkLst>
        </pc:spChg>
        <pc:spChg chg="mod">
          <ac:chgData name="Mareike Schell" userId="+hwTHCJ9DPY+RcXtlOoxeiHCh/r8M9NERwcOBswqpyo=" providerId="None" clId="Web-{92842568-ACA6-4FF0-B290-0595DDCEF770}" dt="2025-05-02T22:19:44.136" v="185" actId="1076"/>
          <ac:spMkLst>
            <pc:docMk/>
            <pc:sldMk cId="459051783" sldId="2280"/>
            <ac:spMk id="34" creationId="{27DEC4EB-8210-F330-8699-9B4A582A7DA1}"/>
          </ac:spMkLst>
        </pc:spChg>
        <pc:spChg chg="mod">
          <ac:chgData name="Mareike Schell" userId="+hwTHCJ9DPY+RcXtlOoxeiHCh/r8M9NERwcOBswqpyo=" providerId="None" clId="Web-{92842568-ACA6-4FF0-B290-0595DDCEF770}" dt="2025-05-02T22:19:29.182" v="177" actId="1076"/>
          <ac:spMkLst>
            <pc:docMk/>
            <pc:sldMk cId="459051783" sldId="2280"/>
            <ac:spMk id="65" creationId="{3353F172-8E2D-D17D-3089-70122D299134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66" creationId="{4692D747-95A7-FDA9-F3FB-00E230374148}"/>
          </ac:spMkLst>
        </pc:spChg>
        <pc:spChg chg="mod">
          <ac:chgData name="Mareike Schell" userId="+hwTHCJ9DPY+RcXtlOoxeiHCh/r8M9NERwcOBswqpyo=" providerId="None" clId="Web-{92842568-ACA6-4FF0-B290-0595DDCEF770}" dt="2025-05-02T22:19:34.057" v="181" actId="1076"/>
          <ac:spMkLst>
            <pc:docMk/>
            <pc:sldMk cId="459051783" sldId="2280"/>
            <ac:spMk id="69" creationId="{B6CC28BD-61EC-758A-CEE0-4810A441FA91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84" creationId="{0306307D-B979-D43B-CD11-5AE5124C31E6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88" creationId="{1E9BE69A-D0CF-B0AC-A1AC-375B5A6B1F22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00" creationId="{2A182F72-85E1-A235-B8EA-C99C7A24AFA4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07" creationId="{B2F1C922-B519-0F24-A40B-A78B65B80F09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12" creationId="{B422BFCF-499A-1EA2-D6B4-9409148052D0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16" creationId="{E208B5B3-F7AB-8B7C-948B-C25340F795D0}"/>
          </ac:spMkLst>
        </pc:spChg>
        <pc:spChg chg="mod">
          <ac:chgData name="Mareike Schell" userId="+hwTHCJ9DPY+RcXtlOoxeiHCh/r8M9NERwcOBswqpyo=" providerId="None" clId="Web-{92842568-ACA6-4FF0-B290-0595DDCEF770}" dt="2025-05-02T22:19:29.214" v="178" actId="1076"/>
          <ac:spMkLst>
            <pc:docMk/>
            <pc:sldMk cId="459051783" sldId="2280"/>
            <ac:spMk id="119" creationId="{4ED3FE10-5FD8-8676-BA03-9EBEF5283149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20" creationId="{8922343C-9A58-2616-5BF6-687FBC2BF168}"/>
          </ac:spMkLst>
        </pc:spChg>
        <pc:grpChg chg="add del">
          <ac:chgData name="Mareike Schell" userId="+hwTHCJ9DPY+RcXtlOoxeiHCh/r8M9NERwcOBswqpyo=" providerId="None" clId="Web-{92842568-ACA6-4FF0-B290-0595DDCEF770}" dt="2025-05-02T22:17:28.194" v="141"/>
          <ac:grpSpMkLst>
            <pc:docMk/>
            <pc:sldMk cId="459051783" sldId="2280"/>
            <ac:grpSpMk id="2" creationId="{908CE240-C904-3ADB-540F-6998173295B9}"/>
          </ac:grpSpMkLst>
        </pc:grpChg>
        <pc:graphicFrameChg chg="mod">
          <ac:chgData name="Mareike Schell" userId="+hwTHCJ9DPY+RcXtlOoxeiHCh/r8M9NERwcOBswqpyo=" providerId="None" clId="Web-{92842568-ACA6-4FF0-B290-0595DDCEF770}" dt="2025-05-02T22:19:44.105" v="184" actId="1076"/>
          <ac:graphicFrameMkLst>
            <pc:docMk/>
            <pc:sldMk cId="459051783" sldId="2280"/>
            <ac:graphicFrameMk id="32" creationId="{8323550C-CAA8-CD19-AAB1-16F8DE4BA7D2}"/>
          </ac:graphicFrameMkLst>
        </pc:graphicFrameChg>
        <pc:graphicFrameChg chg="mod">
          <ac:chgData name="Mareike Schell" userId="+hwTHCJ9DPY+RcXtlOoxeiHCh/r8M9NERwcOBswqpyo=" providerId="None" clId="Web-{92842568-ACA6-4FF0-B290-0595DDCEF770}" dt="2025-05-02T22:19:29.151" v="176" actId="1076"/>
          <ac:graphicFrameMkLst>
            <pc:docMk/>
            <pc:sldMk cId="459051783" sldId="2280"/>
            <ac:graphicFrameMk id="63" creationId="{64D06C85-6552-E708-267A-5E8DC415877E}"/>
          </ac:graphicFrameMkLst>
        </pc:graphicFrameChg>
        <pc:graphicFrameChg chg="mod">
          <ac:chgData name="Mareike Schell" userId="+hwTHCJ9DPY+RcXtlOoxeiHCh/r8M9NERwcOBswqpyo=" providerId="None" clId="Web-{92842568-ACA6-4FF0-B290-0595DDCEF770}" dt="2025-05-02T22:19:34.011" v="180" actId="1076"/>
          <ac:graphicFrameMkLst>
            <pc:docMk/>
            <pc:sldMk cId="459051783" sldId="2280"/>
            <ac:graphicFrameMk id="68" creationId="{9868219A-2DDE-D7AE-E945-D36EAEFADBB6}"/>
          </ac:graphicFrameMkLst>
        </pc:graphicFrameChg>
        <pc:cxnChg chg="add del mod">
          <ac:chgData name="Mareike Schell" userId="+hwTHCJ9DPY+RcXtlOoxeiHCh/r8M9NERwcOBswqpyo=" providerId="None" clId="Web-{92842568-ACA6-4FF0-B290-0595DDCEF770}" dt="2025-05-02T22:19:57.215" v="187"/>
          <ac:cxnSpMkLst>
            <pc:docMk/>
            <pc:sldMk cId="459051783" sldId="2280"/>
            <ac:cxnSpMk id="26" creationId="{F1B4FF4F-98B5-EA33-1243-2009F14444E9}"/>
          </ac:cxnSpMkLst>
        </pc:cxnChg>
      </pc:sldChg>
    </pc:docChg>
  </pc:docChgLst>
  <pc:docChgLst>
    <pc:chgData name="Mareike Schell" userId="+hwTHCJ9DPY+RcXtlOoxeiHCh/r8M9NERwcOBswqpyo=" providerId="None" clId="Web-{105243D0-230D-4A85-9D06-0BF99DA71ECB}"/>
    <pc:docChg chg="modSld sldOrd">
      <pc:chgData name="Mareike Schell" userId="+hwTHCJ9DPY+RcXtlOoxeiHCh/r8M9NERwcOBswqpyo=" providerId="None" clId="Web-{105243D0-230D-4A85-9D06-0BF99DA71ECB}" dt="2025-06-20T20:45:51.369" v="3" actId="20577"/>
      <pc:docMkLst>
        <pc:docMk/>
      </pc:docMkLst>
      <pc:sldChg chg="modSp">
        <pc:chgData name="Mareike Schell" userId="+hwTHCJ9DPY+RcXtlOoxeiHCh/r8M9NERwcOBswqpyo=" providerId="None" clId="Web-{105243D0-230D-4A85-9D06-0BF99DA71ECB}" dt="2025-06-20T20:45:51.369" v="3" actId="20577"/>
        <pc:sldMkLst>
          <pc:docMk/>
          <pc:sldMk cId="604687140" sldId="2262"/>
        </pc:sldMkLst>
        <pc:spChg chg="mod">
          <ac:chgData name="Mareike Schell" userId="+hwTHCJ9DPY+RcXtlOoxeiHCh/r8M9NERwcOBswqpyo=" providerId="None" clId="Web-{105243D0-230D-4A85-9D06-0BF99DA71ECB}" dt="2025-06-20T20:45:51.369" v="3" actId="20577"/>
          <ac:spMkLst>
            <pc:docMk/>
            <pc:sldMk cId="604687140" sldId="2262"/>
            <ac:spMk id="211" creationId="{174E3E88-3800-7243-D6A2-12C1978CFDD7}"/>
          </ac:spMkLst>
        </pc:spChg>
      </pc:sldChg>
      <pc:sldChg chg="modSp ord">
        <pc:chgData name="Mareike Schell" userId="+hwTHCJ9DPY+RcXtlOoxeiHCh/r8M9NERwcOBswqpyo=" providerId="None" clId="Web-{105243D0-230D-4A85-9D06-0BF99DA71ECB}" dt="2025-06-20T20:45:47.165" v="2" actId="20577"/>
        <pc:sldMkLst>
          <pc:docMk/>
          <pc:sldMk cId="2105458467" sldId="2283"/>
        </pc:sldMkLst>
        <pc:spChg chg="mod">
          <ac:chgData name="Mareike Schell" userId="+hwTHCJ9DPY+RcXtlOoxeiHCh/r8M9NERwcOBswqpyo=" providerId="None" clId="Web-{105243D0-230D-4A85-9D06-0BF99DA71ECB}" dt="2025-06-20T20:45:47.165" v="2" actId="20577"/>
          <ac:spMkLst>
            <pc:docMk/>
            <pc:sldMk cId="2105458467" sldId="2283"/>
            <ac:spMk id="7" creationId="{7730057E-B75C-B8F1-09E6-EF14151BAC4A}"/>
          </ac:spMkLst>
        </pc:spChg>
      </pc:sldChg>
    </pc:docChg>
  </pc:docChgLst>
  <pc:docChgLst>
    <pc:chgData name="Mareike Schell" userId="+hwTHCJ9DPY+RcXtlOoxeiHCh/r8M9NERwcOBswqpyo=" providerId="None" clId="Web-{9ADCC2D3-70B3-4043-AB62-6F6C91297EF6}"/>
    <pc:docChg chg="modSld">
      <pc:chgData name="Mareike Schell" userId="+hwTHCJ9DPY+RcXtlOoxeiHCh/r8M9NERwcOBswqpyo=" providerId="None" clId="Web-{9ADCC2D3-70B3-4043-AB62-6F6C91297EF6}" dt="2025-05-02T23:23:05.316" v="6" actId="20577"/>
      <pc:docMkLst>
        <pc:docMk/>
      </pc:docMkLst>
      <pc:sldChg chg="modSp">
        <pc:chgData name="Mareike Schell" userId="+hwTHCJ9DPY+RcXtlOoxeiHCh/r8M9NERwcOBswqpyo=" providerId="None" clId="Web-{9ADCC2D3-70B3-4043-AB62-6F6C91297EF6}" dt="2025-05-02T23:22:52.659" v="4" actId="20577"/>
        <pc:sldMkLst>
          <pc:docMk/>
          <pc:sldMk cId="3419203025" sldId="2260"/>
        </pc:sldMkLst>
        <pc:spChg chg="mod">
          <ac:chgData name="Mareike Schell" userId="+hwTHCJ9DPY+RcXtlOoxeiHCh/r8M9NERwcOBswqpyo=" providerId="None" clId="Web-{9ADCC2D3-70B3-4043-AB62-6F6C91297EF6}" dt="2025-05-02T23:22:52.659" v="4" actId="20577"/>
          <ac:spMkLst>
            <pc:docMk/>
            <pc:sldMk cId="3419203025" sldId="2260"/>
            <ac:spMk id="252" creationId="{1BF8FC5C-5A86-EF66-E60A-C0E4B0A1E09E}"/>
          </ac:spMkLst>
        </pc:spChg>
      </pc:sldChg>
      <pc:sldChg chg="modSp">
        <pc:chgData name="Mareike Schell" userId="+hwTHCJ9DPY+RcXtlOoxeiHCh/r8M9NERwcOBswqpyo=" providerId="None" clId="Web-{9ADCC2D3-70B3-4043-AB62-6F6C91297EF6}" dt="2025-05-02T23:23:05.316" v="6" actId="20577"/>
        <pc:sldMkLst>
          <pc:docMk/>
          <pc:sldMk cId="604687140" sldId="2262"/>
        </pc:sldMkLst>
        <pc:spChg chg="mod">
          <ac:chgData name="Mareike Schell" userId="+hwTHCJ9DPY+RcXtlOoxeiHCh/r8M9NERwcOBswqpyo=" providerId="None" clId="Web-{9ADCC2D3-70B3-4043-AB62-6F6C91297EF6}" dt="2025-05-02T23:23:05.316" v="6" actId="20577"/>
          <ac:spMkLst>
            <pc:docMk/>
            <pc:sldMk cId="604687140" sldId="2262"/>
            <ac:spMk id="271" creationId="{39C151FB-3E65-7BA5-BD19-E8588ED1F7B0}"/>
          </ac:spMkLst>
        </pc:spChg>
      </pc:sldChg>
    </pc:docChg>
  </pc:docChgLst>
  <pc:docChgLst>
    <pc:chgData name="Mareike Schell" userId="+hwTHCJ9DPY+RcXtlOoxeiHCh/r8M9NERwcOBswqpyo=" providerId="None" clId="Web-{6C2CC828-A83C-4AAC-92D0-9AF3D4BC5B7A}"/>
    <pc:docChg chg="delSld">
      <pc:chgData name="Mareike Schell" userId="+hwTHCJ9DPY+RcXtlOoxeiHCh/r8M9NERwcOBswqpyo=" providerId="None" clId="Web-{6C2CC828-A83C-4AAC-92D0-9AF3D4BC5B7A}" dt="2025-05-03T23:31:10.031" v="4"/>
      <pc:docMkLst>
        <pc:docMk/>
      </pc:docMkLst>
      <pc:sldChg chg="del">
        <pc:chgData name="Mareike Schell" userId="+hwTHCJ9DPY+RcXtlOoxeiHCh/r8M9NERwcOBswqpyo=" providerId="None" clId="Web-{6C2CC828-A83C-4AAC-92D0-9AF3D4BC5B7A}" dt="2025-05-03T23:31:10.031" v="4"/>
        <pc:sldMkLst>
          <pc:docMk/>
          <pc:sldMk cId="1311454994" sldId="2269"/>
        </pc:sldMkLst>
      </pc:sldChg>
      <pc:sldChg chg="del">
        <pc:chgData name="Mareike Schell" userId="+hwTHCJ9DPY+RcXtlOoxeiHCh/r8M9NERwcOBswqpyo=" providerId="None" clId="Web-{6C2CC828-A83C-4AAC-92D0-9AF3D4BC5B7A}" dt="2025-05-03T23:31:01.764" v="0"/>
        <pc:sldMkLst>
          <pc:docMk/>
          <pc:sldMk cId="2534225001" sldId="2276"/>
        </pc:sldMkLst>
      </pc:sldChg>
      <pc:sldChg chg="del">
        <pc:chgData name="Mareike Schell" userId="+hwTHCJ9DPY+RcXtlOoxeiHCh/r8M9NERwcOBswqpyo=" providerId="None" clId="Web-{6C2CC828-A83C-4AAC-92D0-9AF3D4BC5B7A}" dt="2025-05-03T23:31:06.343" v="2"/>
        <pc:sldMkLst>
          <pc:docMk/>
          <pc:sldMk cId="121866281" sldId="2278"/>
        </pc:sldMkLst>
      </pc:sldChg>
      <pc:sldChg chg="del">
        <pc:chgData name="Mareike Schell" userId="+hwTHCJ9DPY+RcXtlOoxeiHCh/r8M9NERwcOBswqpyo=" providerId="None" clId="Web-{6C2CC828-A83C-4AAC-92D0-9AF3D4BC5B7A}" dt="2025-05-03T23:31:04.296" v="1"/>
        <pc:sldMkLst>
          <pc:docMk/>
          <pc:sldMk cId="263700232" sldId="2279"/>
        </pc:sldMkLst>
      </pc:sldChg>
      <pc:sldChg chg="del">
        <pc:chgData name="Mareike Schell" userId="+hwTHCJ9DPY+RcXtlOoxeiHCh/r8M9NERwcOBswqpyo=" providerId="None" clId="Web-{6C2CC828-A83C-4AAC-92D0-9AF3D4BC5B7A}" dt="2025-05-03T23:31:08.421" v="3"/>
        <pc:sldMkLst>
          <pc:docMk/>
          <pc:sldMk cId="1470452761" sldId="2282"/>
        </pc:sldMkLst>
      </pc:sldChg>
    </pc:docChg>
  </pc:docChgLst>
  <pc:docChgLst>
    <pc:chgData name="Mareike Schell" userId="+hwTHCJ9DPY+RcXtlOoxeiHCh/r8M9NERwcOBswqpyo=" providerId="None" clId="Web-{6B771CB8-5B8A-46C4-BD43-ECA176944BA4}"/>
    <pc:docChg chg="modSld">
      <pc:chgData name="Mareike Schell" userId="+hwTHCJ9DPY+RcXtlOoxeiHCh/r8M9NERwcOBswqpyo=" providerId="None" clId="Web-{6B771CB8-5B8A-46C4-BD43-ECA176944BA4}" dt="2025-06-05T15:12:30.297" v="7" actId="1076"/>
      <pc:docMkLst>
        <pc:docMk/>
      </pc:docMkLst>
      <pc:sldChg chg="addSp modSp">
        <pc:chgData name="Mareike Schell" userId="+hwTHCJ9DPY+RcXtlOoxeiHCh/r8M9NERwcOBswqpyo=" providerId="None" clId="Web-{6B771CB8-5B8A-46C4-BD43-ECA176944BA4}" dt="2025-06-05T15:12:30.297" v="7" actId="1076"/>
        <pc:sldMkLst>
          <pc:docMk/>
          <pc:sldMk cId="1691594351" sldId="2270"/>
        </pc:sldMkLst>
        <pc:spChg chg="add mod">
          <ac:chgData name="Mareike Schell" userId="+hwTHCJ9DPY+RcXtlOoxeiHCh/r8M9NERwcOBswqpyo=" providerId="None" clId="Web-{6B771CB8-5B8A-46C4-BD43-ECA176944BA4}" dt="2025-06-05T15:12:30.297" v="7" actId="1076"/>
          <ac:spMkLst>
            <pc:docMk/>
            <pc:sldMk cId="1691594351" sldId="2270"/>
            <ac:spMk id="22" creationId="{42A24069-71DE-949D-E209-59B51AC2C383}"/>
          </ac:spMkLst>
        </pc:spChg>
        <pc:spChg chg="mod">
          <ac:chgData name="Mareike Schell" userId="+hwTHCJ9DPY+RcXtlOoxeiHCh/r8M9NERwcOBswqpyo=" providerId="None" clId="Web-{6B771CB8-5B8A-46C4-BD43-ECA176944BA4}" dt="2025-06-05T15:12:12.969" v="3" actId="20577"/>
          <ac:spMkLst>
            <pc:docMk/>
            <pc:sldMk cId="1691594351" sldId="2270"/>
            <ac:spMk id="34" creationId="{833BF64A-985B-6CFD-BA2F-30B59E3BBD1A}"/>
          </ac:spMkLst>
        </pc:spChg>
      </pc:sldChg>
    </pc:docChg>
  </pc:docChgLst>
  <pc:docChgLst>
    <pc:chgData name="Mareike Schell" userId="+hwTHCJ9DPY+RcXtlOoxeiHCh/r8M9NERwcOBswqpyo=" providerId="None" clId="Web-{2165B5CB-A405-40F9-9B6D-C976A6FD1273}"/>
    <pc:docChg chg="modSld">
      <pc:chgData name="Mareike Schell" userId="+hwTHCJ9DPY+RcXtlOoxeiHCh/r8M9NERwcOBswqpyo=" providerId="None" clId="Web-{2165B5CB-A405-40F9-9B6D-C976A6FD1273}" dt="2025-06-18T20:41:44.502" v="68"/>
      <pc:docMkLst>
        <pc:docMk/>
      </pc:docMkLst>
      <pc:sldChg chg="addSp delSp modSp">
        <pc:chgData name="Mareike Schell" userId="+hwTHCJ9DPY+RcXtlOoxeiHCh/r8M9NERwcOBswqpyo=" providerId="None" clId="Web-{2165B5CB-A405-40F9-9B6D-C976A6FD1273}" dt="2025-06-18T20:41:44.502" v="68"/>
        <pc:sldMkLst>
          <pc:docMk/>
          <pc:sldMk cId="2105458467" sldId="2283"/>
        </pc:sldMkLst>
        <pc:spChg chg="mod">
          <ac:chgData name="Mareike Schell" userId="+hwTHCJ9DPY+RcXtlOoxeiHCh/r8M9NERwcOBswqpyo=" providerId="None" clId="Web-{2165B5CB-A405-40F9-9B6D-C976A6FD1273}" dt="2025-06-18T20:41:29.095" v="59" actId="1076"/>
          <ac:spMkLst>
            <pc:docMk/>
            <pc:sldMk cId="2105458467" sldId="2283"/>
            <ac:spMk id="20" creationId="{618AA4CC-3E26-D8A3-AC7A-15E7738EF09B}"/>
          </ac:spMkLst>
        </pc:spChg>
        <pc:spChg chg="del mod">
          <ac:chgData name="Mareike Schell" userId="+hwTHCJ9DPY+RcXtlOoxeiHCh/r8M9NERwcOBswqpyo=" providerId="None" clId="Web-{2165B5CB-A405-40F9-9B6D-C976A6FD1273}" dt="2025-06-18T20:40:35.718" v="21"/>
          <ac:spMkLst>
            <pc:docMk/>
            <pc:sldMk cId="2105458467" sldId="2283"/>
            <ac:spMk id="21" creationId="{78CEB8C7-CC3D-BB06-5B57-E3A826AC8C92}"/>
          </ac:spMkLst>
        </pc:spChg>
        <pc:spChg chg="mod">
          <ac:chgData name="Mareike Schell" userId="+hwTHCJ9DPY+RcXtlOoxeiHCh/r8M9NERwcOBswqpyo=" providerId="None" clId="Web-{2165B5CB-A405-40F9-9B6D-C976A6FD1273}" dt="2025-06-18T20:41:29.173" v="60" actId="1076"/>
          <ac:spMkLst>
            <pc:docMk/>
            <pc:sldMk cId="2105458467" sldId="2283"/>
            <ac:spMk id="22" creationId="{A1A6C24D-FECE-59DA-B996-8DFE9DE853F2}"/>
          </ac:spMkLst>
        </pc:spChg>
        <pc:spChg chg="mod">
          <ac:chgData name="Mareike Schell" userId="+hwTHCJ9DPY+RcXtlOoxeiHCh/r8M9NERwcOBswqpyo=" providerId="None" clId="Web-{2165B5CB-A405-40F9-9B6D-C976A6FD1273}" dt="2025-06-18T20:41:29.251" v="61" actId="1076"/>
          <ac:spMkLst>
            <pc:docMk/>
            <pc:sldMk cId="2105458467" sldId="2283"/>
            <ac:spMk id="23" creationId="{A42A442F-B98B-706D-6B50-F9D813670D0B}"/>
          </ac:spMkLst>
        </pc:spChg>
        <pc:spChg chg="mod">
          <ac:chgData name="Mareike Schell" userId="+hwTHCJ9DPY+RcXtlOoxeiHCh/r8M9NERwcOBswqpyo=" providerId="None" clId="Web-{2165B5CB-A405-40F9-9B6D-C976A6FD1273}" dt="2025-06-18T20:41:29.407" v="62" actId="1076"/>
          <ac:spMkLst>
            <pc:docMk/>
            <pc:sldMk cId="2105458467" sldId="2283"/>
            <ac:spMk id="24" creationId="{E16C5DE1-F2ED-1EB1-FF6C-08C5706DA404}"/>
          </ac:spMkLst>
        </pc:spChg>
        <pc:grpChg chg="mod">
          <ac:chgData name="Mareike Schell" userId="+hwTHCJ9DPY+RcXtlOoxeiHCh/r8M9NERwcOBswqpyo=" providerId="None" clId="Web-{2165B5CB-A405-40F9-9B6D-C976A6FD1273}" dt="2025-06-18T20:39:03.309" v="0" actId="1076"/>
          <ac:grpSpMkLst>
            <pc:docMk/>
            <pc:sldMk cId="2105458467" sldId="2283"/>
            <ac:grpSpMk id="6" creationId="{CC359C9F-7BC9-47CF-BEFC-0DA61A45203F}"/>
          </ac:grpSpMkLst>
        </pc:grpChg>
        <pc:picChg chg="mod">
          <ac:chgData name="Mareike Schell" userId="+hwTHCJ9DPY+RcXtlOoxeiHCh/r8M9NERwcOBswqpyo=" providerId="None" clId="Web-{2165B5CB-A405-40F9-9B6D-C976A6FD1273}" dt="2025-06-18T20:41:36.767" v="65" actId="1076"/>
          <ac:picMkLst>
            <pc:docMk/>
            <pc:sldMk cId="2105458467" sldId="2283"/>
            <ac:picMk id="18" creationId="{6E240840-1449-DA4C-6AC0-EB1FC169058B}"/>
          </ac:picMkLst>
        </pc:picChg>
        <pc:picChg chg="mod">
          <ac:chgData name="Mareike Schell" userId="+hwTHCJ9DPY+RcXtlOoxeiHCh/r8M9NERwcOBswqpyo=" providerId="None" clId="Web-{2165B5CB-A405-40F9-9B6D-C976A6FD1273}" dt="2025-06-18T20:39:30.638" v="8" actId="1076"/>
          <ac:picMkLst>
            <pc:docMk/>
            <pc:sldMk cId="2105458467" sldId="2283"/>
            <ac:picMk id="25" creationId="{893FF338-FEF2-3D63-8B17-F48584EFABB2}"/>
          </ac:picMkLst>
        </pc:picChg>
        <pc:picChg chg="mod">
          <ac:chgData name="Mareike Schell" userId="+hwTHCJ9DPY+RcXtlOoxeiHCh/r8M9NERwcOBswqpyo=" providerId="None" clId="Web-{2165B5CB-A405-40F9-9B6D-C976A6FD1273}" dt="2025-06-18T20:41:41.642" v="67" actId="1076"/>
          <ac:picMkLst>
            <pc:docMk/>
            <pc:sldMk cId="2105458467" sldId="2283"/>
            <ac:picMk id="26" creationId="{EFB16A03-E386-547F-FCE8-9303B0799495}"/>
          </ac:picMkLst>
        </pc:picChg>
        <pc:picChg chg="mod">
          <ac:chgData name="Mareike Schell" userId="+hwTHCJ9DPY+RcXtlOoxeiHCh/r8M9NERwcOBswqpyo=" providerId="None" clId="Web-{2165B5CB-A405-40F9-9B6D-C976A6FD1273}" dt="2025-06-18T20:41:36.861" v="66" actId="1076"/>
          <ac:picMkLst>
            <pc:docMk/>
            <pc:sldMk cId="2105458467" sldId="2283"/>
            <ac:picMk id="27" creationId="{076030E0-19B1-1657-571D-19A6133B904D}"/>
          </ac:picMkLst>
        </pc:picChg>
        <pc:cxnChg chg="add del mod">
          <ac:chgData name="Mareike Schell" userId="+hwTHCJ9DPY+RcXtlOoxeiHCh/r8M9NERwcOBswqpyo=" providerId="None" clId="Web-{2165B5CB-A405-40F9-9B6D-C976A6FD1273}" dt="2025-06-18T20:41:44.502" v="68"/>
          <ac:cxnSpMkLst>
            <pc:docMk/>
            <pc:sldMk cId="2105458467" sldId="2283"/>
            <ac:cxnSpMk id="30" creationId="{A775A2B3-A78C-99EB-06CE-E35072B4883E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r">
              <a:defRPr sz="1200"/>
            </a:lvl1pPr>
          </a:lstStyle>
          <a:p>
            <a:fld id="{B8E76031-5083-42A3-AEB2-84104042EB62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6" tIns="46584" rIns="93166" bIns="465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9"/>
          </a:xfrm>
          <a:prstGeom prst="rect">
            <a:avLst/>
          </a:prstGeom>
        </p:spPr>
        <p:txBody>
          <a:bodyPr vert="horz" lIns="93166" tIns="46584" rIns="93166" bIns="4658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r">
              <a:defRPr sz="1200"/>
            </a:lvl1pPr>
          </a:lstStyle>
          <a:p>
            <a:fld id="{716B66B5-9926-446B-9214-7B7D28BAF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3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1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7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50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5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56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25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80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4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36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46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58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A8459-7E93-4F1B-BD53-910F08855FC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6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emf"/><Relationship Id="rId18" Type="http://schemas.openxmlformats.org/officeDocument/2006/relationships/oleObject" Target="../embeddings/oleObject9.bin"/><Relationship Id="rId26" Type="http://schemas.openxmlformats.org/officeDocument/2006/relationships/oleObject" Target="../embeddings/oleObject13.bin"/><Relationship Id="rId3" Type="http://schemas.openxmlformats.org/officeDocument/2006/relationships/image" Target="../media/image1.emf"/><Relationship Id="rId21" Type="http://schemas.openxmlformats.org/officeDocument/2006/relationships/image" Target="../media/image10.emf"/><Relationship Id="rId34" Type="http://schemas.openxmlformats.org/officeDocument/2006/relationships/oleObject" Target="../embeddings/oleObject17.bin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5" Type="http://schemas.openxmlformats.org/officeDocument/2006/relationships/image" Target="../media/image12.emf"/><Relationship Id="rId33" Type="http://schemas.openxmlformats.org/officeDocument/2006/relationships/image" Target="../media/image16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oleObject" Target="../embeddings/oleObject10.bin"/><Relationship Id="rId29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24" Type="http://schemas.openxmlformats.org/officeDocument/2006/relationships/oleObject" Target="../embeddings/oleObject12.bin"/><Relationship Id="rId32" Type="http://schemas.openxmlformats.org/officeDocument/2006/relationships/oleObject" Target="../embeddings/oleObject16.bin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23" Type="http://schemas.openxmlformats.org/officeDocument/2006/relationships/image" Target="../media/image11.emf"/><Relationship Id="rId28" Type="http://schemas.openxmlformats.org/officeDocument/2006/relationships/oleObject" Target="../embeddings/oleObject14.bin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9.emf"/><Relationship Id="rId31" Type="http://schemas.openxmlformats.org/officeDocument/2006/relationships/image" Target="../media/image15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Relationship Id="rId22" Type="http://schemas.openxmlformats.org/officeDocument/2006/relationships/oleObject" Target="../embeddings/oleObject11.bin"/><Relationship Id="rId27" Type="http://schemas.openxmlformats.org/officeDocument/2006/relationships/image" Target="../media/image13.emf"/><Relationship Id="rId30" Type="http://schemas.openxmlformats.org/officeDocument/2006/relationships/oleObject" Target="../embeddings/oleObject15.bin"/><Relationship Id="rId35" Type="http://schemas.openxmlformats.org/officeDocument/2006/relationships/image" Target="../media/image17.emf"/><Relationship Id="rId8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ACF1A90-D637-D50B-B619-4945DB09359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40072BDD-6CAA-A05E-F296-1E430AC8DFB8}"/>
              </a:ext>
            </a:extLst>
          </p:cNvPr>
          <p:cNvSpPr txBox="1">
            <a:spLocks/>
          </p:cNvSpPr>
          <p:nvPr/>
        </p:nvSpPr>
        <p:spPr>
          <a:xfrm>
            <a:off x="241716" y="412425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3815844-23AC-E4BA-ED00-63A5ED663648}"/>
              </a:ext>
            </a:extLst>
          </p:cNvPr>
          <p:cNvSpPr txBox="1">
            <a:spLocks/>
          </p:cNvSpPr>
          <p:nvPr/>
        </p:nvSpPr>
        <p:spPr>
          <a:xfrm>
            <a:off x="241716" y="1822838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8D6FCA2-BA30-B827-B4B1-30A4D8CA9F7F}"/>
              </a:ext>
            </a:extLst>
          </p:cNvPr>
          <p:cNvSpPr txBox="1">
            <a:spLocks/>
          </p:cNvSpPr>
          <p:nvPr/>
        </p:nvSpPr>
        <p:spPr>
          <a:xfrm>
            <a:off x="241716" y="3215883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BB43022-C06A-89FB-D602-A8CF2761A85A}"/>
              </a:ext>
            </a:extLst>
          </p:cNvPr>
          <p:cNvSpPr txBox="1">
            <a:spLocks/>
          </p:cNvSpPr>
          <p:nvPr/>
        </p:nvSpPr>
        <p:spPr>
          <a:xfrm>
            <a:off x="241716" y="4605839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52B63A70-4E34-C2EA-6F45-27D618934C63}"/>
              </a:ext>
            </a:extLst>
          </p:cNvPr>
          <p:cNvSpPr txBox="1">
            <a:spLocks/>
          </p:cNvSpPr>
          <p:nvPr/>
        </p:nvSpPr>
        <p:spPr>
          <a:xfrm>
            <a:off x="246525" y="5991261"/>
            <a:ext cx="120226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algn="l"/>
            <a:r>
              <a:rPr lang="en-US" sz="1400" b="1" dirty="0">
                <a:latin typeface="Arial"/>
                <a:cs typeface="Arial"/>
              </a:rPr>
              <a:t>E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152281B-472E-675F-39D6-A9B79FFF98AF}"/>
              </a:ext>
            </a:extLst>
          </p:cNvPr>
          <p:cNvGrpSpPr/>
          <p:nvPr/>
        </p:nvGrpSpPr>
        <p:grpSpPr>
          <a:xfrm>
            <a:off x="2008329" y="435277"/>
            <a:ext cx="2144711" cy="7161395"/>
            <a:chOff x="2704936" y="435277"/>
            <a:chExt cx="2144711" cy="7161395"/>
          </a:xfrm>
        </p:grpSpPr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F520F51F-A140-D0EB-7A27-8316BC7B157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855888349"/>
                </p:ext>
              </p:extLst>
            </p:nvPr>
          </p:nvGraphicFramePr>
          <p:xfrm>
            <a:off x="2704936" y="435277"/>
            <a:ext cx="2135188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" imgW="2135965" imgH="1580607" progId="Prism10.Document">
                    <p:embed/>
                  </p:oleObj>
                </mc:Choice>
                <mc:Fallback>
                  <p:oleObj name="Prism 10" r:id="rId2" imgW="2135965" imgH="1580607" progId="Prism10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F2E556F2-6367-DF4E-9D3B-D97773D7D67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2704936" y="435277"/>
                          <a:ext cx="2135188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4" name="Object 53">
              <a:extLst>
                <a:ext uri="{FF2B5EF4-FFF2-40B4-BE49-F238E27FC236}">
                  <a16:creationId xmlns:a16="http://schemas.microsoft.com/office/drawing/2014/main" id="{054CB4FA-19BD-06DC-A75A-ABE38F8993F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31773451"/>
                </p:ext>
              </p:extLst>
            </p:nvPr>
          </p:nvGraphicFramePr>
          <p:xfrm>
            <a:off x="2709169" y="1855326"/>
            <a:ext cx="2135187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4" imgW="2135965" imgH="1580607" progId="Prism10.Document">
                    <p:embed/>
                  </p:oleObj>
                </mc:Choice>
                <mc:Fallback>
                  <p:oleObj name="Prism 10" r:id="rId4" imgW="2135965" imgH="1580607" progId="Prism10.Document">
                    <p:embed/>
                    <p:pic>
                      <p:nvPicPr>
                        <p:cNvPr id="54" name="Object 53">
                          <a:extLst>
                            <a:ext uri="{FF2B5EF4-FFF2-40B4-BE49-F238E27FC236}">
                              <a16:creationId xmlns:a16="http://schemas.microsoft.com/office/drawing/2014/main" id="{EB928842-8619-EAB5-F358-B66C8AB9BC3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709169" y="1855326"/>
                          <a:ext cx="2135187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4" name="Object 63">
              <a:extLst>
                <a:ext uri="{FF2B5EF4-FFF2-40B4-BE49-F238E27FC236}">
                  <a16:creationId xmlns:a16="http://schemas.microsoft.com/office/drawing/2014/main" id="{C51E6935-823E-0889-6D27-5882FC364F7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11382601"/>
                </p:ext>
              </p:extLst>
            </p:nvPr>
          </p:nvGraphicFramePr>
          <p:xfrm>
            <a:off x="2707581" y="3245282"/>
            <a:ext cx="2135188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6" imgW="2135965" imgH="1580607" progId="Prism10.Document">
                    <p:embed/>
                  </p:oleObj>
                </mc:Choice>
                <mc:Fallback>
                  <p:oleObj name="Prism 10" r:id="rId6" imgW="2135965" imgH="1580607" progId="Prism10.Document">
                    <p:embed/>
                    <p:pic>
                      <p:nvPicPr>
                        <p:cNvPr id="64" name="Object 63">
                          <a:extLst>
                            <a:ext uri="{FF2B5EF4-FFF2-40B4-BE49-F238E27FC236}">
                              <a16:creationId xmlns:a16="http://schemas.microsoft.com/office/drawing/2014/main" id="{04D67EF5-B536-3306-2231-535973C2BE6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707581" y="3245282"/>
                          <a:ext cx="2135188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3" name="Object 82">
              <a:extLst>
                <a:ext uri="{FF2B5EF4-FFF2-40B4-BE49-F238E27FC236}">
                  <a16:creationId xmlns:a16="http://schemas.microsoft.com/office/drawing/2014/main" id="{5B1CE69E-3D9C-993A-4656-A0E4BCC6F5E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69603919"/>
                </p:ext>
              </p:extLst>
            </p:nvPr>
          </p:nvGraphicFramePr>
          <p:xfrm>
            <a:off x="2713667" y="4630704"/>
            <a:ext cx="2135188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8" imgW="2135965" imgH="1580607" progId="Prism10.Document">
                    <p:embed/>
                  </p:oleObj>
                </mc:Choice>
                <mc:Fallback>
                  <p:oleObj name="Prism 10" r:id="rId8" imgW="2135965" imgH="1580607" progId="Prism10.Document">
                    <p:embed/>
                    <p:pic>
                      <p:nvPicPr>
                        <p:cNvPr id="83" name="Object 82">
                          <a:extLst>
                            <a:ext uri="{FF2B5EF4-FFF2-40B4-BE49-F238E27FC236}">
                              <a16:creationId xmlns:a16="http://schemas.microsoft.com/office/drawing/2014/main" id="{EB9AAE99-EECA-27FF-2CF4-4A781D12AD3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713667" y="4630704"/>
                          <a:ext cx="2135188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1" name="Object 100">
              <a:extLst>
                <a:ext uri="{FF2B5EF4-FFF2-40B4-BE49-F238E27FC236}">
                  <a16:creationId xmlns:a16="http://schemas.microsoft.com/office/drawing/2014/main" id="{2BD2DD41-AB0F-99B9-7702-8C2D48C8A29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26586145"/>
                </p:ext>
              </p:extLst>
            </p:nvPr>
          </p:nvGraphicFramePr>
          <p:xfrm>
            <a:off x="2714459" y="6015522"/>
            <a:ext cx="2135188" cy="1581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0" imgW="2135965" imgH="1580607" progId="Prism10.Document">
                    <p:embed/>
                  </p:oleObj>
                </mc:Choice>
                <mc:Fallback>
                  <p:oleObj name="Prism 10" r:id="rId10" imgW="2135965" imgH="1580607" progId="Prism10.Document">
                    <p:embed/>
                    <p:pic>
                      <p:nvPicPr>
                        <p:cNvPr id="101" name="Object 100">
                          <a:extLst>
                            <a:ext uri="{FF2B5EF4-FFF2-40B4-BE49-F238E27FC236}">
                              <a16:creationId xmlns:a16="http://schemas.microsoft.com/office/drawing/2014/main" id="{970287CF-0AF4-4F57-01FC-1356A83988A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714459" y="6015522"/>
                          <a:ext cx="2135188" cy="1581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39B5E3B1-134D-2031-47D7-823A27E79A3D}"/>
              </a:ext>
            </a:extLst>
          </p:cNvPr>
          <p:cNvGrpSpPr/>
          <p:nvPr/>
        </p:nvGrpSpPr>
        <p:grpSpPr>
          <a:xfrm>
            <a:off x="3811642" y="434218"/>
            <a:ext cx="1652587" cy="6791507"/>
            <a:chOff x="4660842" y="434218"/>
            <a:chExt cx="1652587" cy="6791507"/>
          </a:xfrm>
        </p:grpSpPr>
        <p:graphicFrame>
          <p:nvGraphicFramePr>
            <p:cNvPr id="32" name="Object 31">
              <a:extLst>
                <a:ext uri="{FF2B5EF4-FFF2-40B4-BE49-F238E27FC236}">
                  <a16:creationId xmlns:a16="http://schemas.microsoft.com/office/drawing/2014/main" id="{8323550C-CAA8-CD19-AAB1-16F8DE4BA7D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7820716"/>
                </p:ext>
              </p:extLst>
            </p:nvPr>
          </p:nvGraphicFramePr>
          <p:xfrm>
            <a:off x="4679891" y="434218"/>
            <a:ext cx="1633538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2" imgW="1632855" imgH="1205798" progId="Prism10.Document">
                    <p:embed/>
                  </p:oleObj>
                </mc:Choice>
                <mc:Fallback>
                  <p:oleObj name="Prism 10" r:id="rId12" imgW="1632855" imgH="1205798" progId="Prism10.Document">
                    <p:embed/>
                    <p:pic>
                      <p:nvPicPr>
                        <p:cNvPr id="32" name="Object 31">
                          <a:extLst>
                            <a:ext uri="{FF2B5EF4-FFF2-40B4-BE49-F238E27FC236}">
                              <a16:creationId xmlns:a16="http://schemas.microsoft.com/office/drawing/2014/main" id="{5D1E82D2-1FB5-4C00-71B3-1A568559D15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4679891" y="434218"/>
                          <a:ext cx="1633538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8" name="Object 57">
              <a:extLst>
                <a:ext uri="{FF2B5EF4-FFF2-40B4-BE49-F238E27FC236}">
                  <a16:creationId xmlns:a16="http://schemas.microsoft.com/office/drawing/2014/main" id="{1352716C-6F36-F06B-CBF9-F6EF7F335BA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462202613"/>
                </p:ext>
              </p:extLst>
            </p:nvPr>
          </p:nvGraphicFramePr>
          <p:xfrm>
            <a:off x="4679891" y="1859027"/>
            <a:ext cx="1633538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4" imgW="1632855" imgH="1205798" progId="Prism10.Document">
                    <p:embed/>
                  </p:oleObj>
                </mc:Choice>
                <mc:Fallback>
                  <p:oleObj name="Prism 10" r:id="rId14" imgW="1632855" imgH="1205798" progId="Prism10.Document">
                    <p:embed/>
                    <p:pic>
                      <p:nvPicPr>
                        <p:cNvPr id="58" name="Object 57">
                          <a:extLst>
                            <a:ext uri="{FF2B5EF4-FFF2-40B4-BE49-F238E27FC236}">
                              <a16:creationId xmlns:a16="http://schemas.microsoft.com/office/drawing/2014/main" id="{EAA06E89-8D05-C51A-5AD8-242E07AAB43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5"/>
                        <a:stretch>
                          <a:fillRect/>
                        </a:stretch>
                      </p:blipFill>
                      <p:spPr>
                        <a:xfrm>
                          <a:off x="4679891" y="1859027"/>
                          <a:ext cx="1633538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8" name="Object 67">
              <a:extLst>
                <a:ext uri="{FF2B5EF4-FFF2-40B4-BE49-F238E27FC236}">
                  <a16:creationId xmlns:a16="http://schemas.microsoft.com/office/drawing/2014/main" id="{9868219A-2DDE-D7AE-E945-D36EAEFADBB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18408446"/>
                </p:ext>
              </p:extLst>
            </p:nvPr>
          </p:nvGraphicFramePr>
          <p:xfrm>
            <a:off x="4660842" y="3243165"/>
            <a:ext cx="1652587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6" imgW="1652663" imgH="1205798" progId="Prism10.Document">
                    <p:embed/>
                  </p:oleObj>
                </mc:Choice>
                <mc:Fallback>
                  <p:oleObj name="Prism 10" r:id="rId16" imgW="1652663" imgH="1205798" progId="Prism10.Document">
                    <p:embed/>
                    <p:pic>
                      <p:nvPicPr>
                        <p:cNvPr id="68" name="Object 67">
                          <a:extLst>
                            <a:ext uri="{FF2B5EF4-FFF2-40B4-BE49-F238E27FC236}">
                              <a16:creationId xmlns:a16="http://schemas.microsoft.com/office/drawing/2014/main" id="{C69381D6-C898-57AA-FB85-2C8E796DB6D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4660842" y="3243165"/>
                          <a:ext cx="1652587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7" name="Object 86">
              <a:extLst>
                <a:ext uri="{FF2B5EF4-FFF2-40B4-BE49-F238E27FC236}">
                  <a16:creationId xmlns:a16="http://schemas.microsoft.com/office/drawing/2014/main" id="{A1FEDC89-44A4-724F-8978-E2456905EBB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66098232"/>
                </p:ext>
              </p:extLst>
            </p:nvPr>
          </p:nvGraphicFramePr>
          <p:xfrm>
            <a:off x="4679892" y="4634407"/>
            <a:ext cx="1633537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8" imgW="1632855" imgH="1205798" progId="Prism10.Document">
                    <p:embed/>
                  </p:oleObj>
                </mc:Choice>
                <mc:Fallback>
                  <p:oleObj name="Prism 10" r:id="rId18" imgW="1632855" imgH="1205798" progId="Prism10.Document">
                    <p:embed/>
                    <p:pic>
                      <p:nvPicPr>
                        <p:cNvPr id="87" name="Object 86">
                          <a:extLst>
                            <a:ext uri="{FF2B5EF4-FFF2-40B4-BE49-F238E27FC236}">
                              <a16:creationId xmlns:a16="http://schemas.microsoft.com/office/drawing/2014/main" id="{68BA6DED-5BEE-8394-61BA-FFCFBE55D5D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4679892" y="4634407"/>
                          <a:ext cx="1633537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6" name="Object 105">
              <a:extLst>
                <a:ext uri="{FF2B5EF4-FFF2-40B4-BE49-F238E27FC236}">
                  <a16:creationId xmlns:a16="http://schemas.microsoft.com/office/drawing/2014/main" id="{E95AAA42-FB38-9FDE-A985-63E9CFA3A0BD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3238742"/>
                </p:ext>
              </p:extLst>
            </p:nvPr>
          </p:nvGraphicFramePr>
          <p:xfrm>
            <a:off x="4679891" y="6019225"/>
            <a:ext cx="1633538" cy="1206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0" imgW="1632855" imgH="1205798" progId="Prism10.Document">
                    <p:embed/>
                  </p:oleObj>
                </mc:Choice>
                <mc:Fallback>
                  <p:oleObj name="Prism 10" r:id="rId20" imgW="1632855" imgH="1205798" progId="Prism10.Document">
                    <p:embed/>
                    <p:pic>
                      <p:nvPicPr>
                        <p:cNvPr id="106" name="Object 105">
                          <a:extLst>
                            <a:ext uri="{FF2B5EF4-FFF2-40B4-BE49-F238E27FC236}">
                              <a16:creationId xmlns:a16="http://schemas.microsoft.com/office/drawing/2014/main" id="{92F2743A-4D4E-6670-687A-AADB112B743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4679891" y="6019225"/>
                          <a:ext cx="1633538" cy="1206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9" name="TextBox 98">
            <a:extLst>
              <a:ext uri="{FF2B5EF4-FFF2-40B4-BE49-F238E27FC236}">
                <a16:creationId xmlns:a16="http://schemas.microsoft.com/office/drawing/2014/main" id="{7EDE1F03-4606-8F90-8409-4822A174AF53}"/>
              </a:ext>
            </a:extLst>
          </p:cNvPr>
          <p:cNvSpPr txBox="1">
            <a:spLocks/>
          </p:cNvSpPr>
          <p:nvPr/>
        </p:nvSpPr>
        <p:spPr>
          <a:xfrm>
            <a:off x="252136" y="7376080"/>
            <a:ext cx="10900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 anchor="t">
            <a:spAutoFit/>
          </a:bodyPr>
          <a:lstStyle/>
          <a:p>
            <a:pPr algn="l"/>
            <a:r>
              <a:rPr lang="en-US" sz="1400" b="1" dirty="0">
                <a:latin typeface="Arial"/>
                <a:cs typeface="Arial"/>
              </a:rPr>
              <a:t>F</a:t>
            </a:r>
            <a:endParaRPr lang="de-DE" dirty="0"/>
          </a:p>
        </p:txBody>
      </p:sp>
      <p:graphicFrame>
        <p:nvGraphicFramePr>
          <p:cNvPr id="109" name="Object 108">
            <a:extLst>
              <a:ext uri="{FF2B5EF4-FFF2-40B4-BE49-F238E27FC236}">
                <a16:creationId xmlns:a16="http://schemas.microsoft.com/office/drawing/2014/main" id="{E0D1D7FA-FFEB-8988-D5D5-DB84C0DCC99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83712416"/>
              </p:ext>
            </p:extLst>
          </p:nvPr>
        </p:nvGraphicFramePr>
        <p:xfrm>
          <a:off x="2021596" y="7393788"/>
          <a:ext cx="3684587" cy="166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2" imgW="3684909" imgH="1663058" progId="Prism10.Document">
                  <p:embed/>
                </p:oleObj>
              </mc:Choice>
              <mc:Fallback>
                <p:oleObj name="Prism 10" r:id="rId22" imgW="3684909" imgH="1663058" progId="Prism10.Document">
                  <p:embed/>
                  <p:pic>
                    <p:nvPicPr>
                      <p:cNvPr id="109" name="Object 108">
                        <a:extLst>
                          <a:ext uri="{FF2B5EF4-FFF2-40B4-BE49-F238E27FC236}">
                            <a16:creationId xmlns:a16="http://schemas.microsoft.com/office/drawing/2014/main" id="{B754E862-26F4-DEB6-E328-0684A595EBB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021596" y="7393788"/>
                        <a:ext cx="3684587" cy="1663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7E6C2B3E-EFAF-4946-AAB0-4DAAD2A3EC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0389150"/>
              </p:ext>
            </p:extLst>
          </p:nvPr>
        </p:nvGraphicFramePr>
        <p:xfrm>
          <a:off x="700318" y="435805"/>
          <a:ext cx="1462088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1462151" imgH="1205798" progId="Prism10.Document">
                  <p:embed/>
                </p:oleObj>
              </mc:Choice>
              <mc:Fallback>
                <p:oleObj name="Prism 10" r:id="rId24" imgW="1462151" imgH="1205798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0D33E6E7-4F4E-348E-0CCC-E619B1C332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700318" y="435805"/>
                        <a:ext cx="1462088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3" name="Object 52">
            <a:extLst>
              <a:ext uri="{FF2B5EF4-FFF2-40B4-BE49-F238E27FC236}">
                <a16:creationId xmlns:a16="http://schemas.microsoft.com/office/drawing/2014/main" id="{1E8342A8-4F14-ADFE-AF22-DA5B313D20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0494100"/>
              </p:ext>
            </p:extLst>
          </p:nvPr>
        </p:nvGraphicFramePr>
        <p:xfrm>
          <a:off x="705081" y="1852148"/>
          <a:ext cx="1462087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6" imgW="1462151" imgH="1205798" progId="Prism10.Document">
                  <p:embed/>
                </p:oleObj>
              </mc:Choice>
              <mc:Fallback>
                <p:oleObj name="Prism 10" r:id="rId26" imgW="1462151" imgH="1205798" progId="Prism10.Document">
                  <p:embed/>
                  <p:pic>
                    <p:nvPicPr>
                      <p:cNvPr id="53" name="Object 52">
                        <a:extLst>
                          <a:ext uri="{FF2B5EF4-FFF2-40B4-BE49-F238E27FC236}">
                            <a16:creationId xmlns:a16="http://schemas.microsoft.com/office/drawing/2014/main" id="{31249EE6-7D99-1BA3-0ABD-C328B96BDDF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705081" y="1852148"/>
                        <a:ext cx="1462087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3" name="Object 62">
            <a:extLst>
              <a:ext uri="{FF2B5EF4-FFF2-40B4-BE49-F238E27FC236}">
                <a16:creationId xmlns:a16="http://schemas.microsoft.com/office/drawing/2014/main" id="{64D06C85-6552-E708-267A-5E8DC41587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89229163"/>
              </p:ext>
            </p:extLst>
          </p:nvPr>
        </p:nvGraphicFramePr>
        <p:xfrm>
          <a:off x="705606" y="3243691"/>
          <a:ext cx="1462088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8" imgW="1462151" imgH="1205798" progId="Prism10.Document">
                  <p:embed/>
                </p:oleObj>
              </mc:Choice>
              <mc:Fallback>
                <p:oleObj name="Prism 10" r:id="rId28" imgW="1462151" imgH="1205798" progId="Prism10.Document">
                  <p:embed/>
                  <p:pic>
                    <p:nvPicPr>
                      <p:cNvPr id="63" name="Object 62">
                        <a:extLst>
                          <a:ext uri="{FF2B5EF4-FFF2-40B4-BE49-F238E27FC236}">
                            <a16:creationId xmlns:a16="http://schemas.microsoft.com/office/drawing/2014/main" id="{61DA3F47-93D6-4C91-965A-0DEAD4AB54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705606" y="3243691"/>
                        <a:ext cx="1462088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2" name="Object 81">
            <a:extLst>
              <a:ext uri="{FF2B5EF4-FFF2-40B4-BE49-F238E27FC236}">
                <a16:creationId xmlns:a16="http://schemas.microsoft.com/office/drawing/2014/main" id="{D9A3297D-5F06-E725-93D8-60E1B0158AA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236915"/>
              </p:ext>
            </p:extLst>
          </p:nvPr>
        </p:nvGraphicFramePr>
        <p:xfrm>
          <a:off x="708255" y="4635995"/>
          <a:ext cx="1462087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0" imgW="1462151" imgH="1205798" progId="Prism10.Document">
                  <p:embed/>
                </p:oleObj>
              </mc:Choice>
              <mc:Fallback>
                <p:oleObj name="Prism 10" r:id="rId30" imgW="1462151" imgH="1205798" progId="Prism10.Document">
                  <p:embed/>
                  <p:pic>
                    <p:nvPicPr>
                      <p:cNvPr id="82" name="Object 81">
                        <a:extLst>
                          <a:ext uri="{FF2B5EF4-FFF2-40B4-BE49-F238E27FC236}">
                            <a16:creationId xmlns:a16="http://schemas.microsoft.com/office/drawing/2014/main" id="{08DA8B0D-00FA-6CE8-C737-070DF07D0A9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708255" y="4635995"/>
                        <a:ext cx="1462087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" name="Object 101">
            <a:extLst>
              <a:ext uri="{FF2B5EF4-FFF2-40B4-BE49-F238E27FC236}">
                <a16:creationId xmlns:a16="http://schemas.microsoft.com/office/drawing/2014/main" id="{2E5869FA-76B2-4F1C-EC2C-DE5E0C32530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6681859"/>
              </p:ext>
            </p:extLst>
          </p:nvPr>
        </p:nvGraphicFramePr>
        <p:xfrm>
          <a:off x="709840" y="6021341"/>
          <a:ext cx="1462088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2" imgW="1462151" imgH="1205798" progId="Prism10.Document">
                  <p:embed/>
                </p:oleObj>
              </mc:Choice>
              <mc:Fallback>
                <p:oleObj name="Prism 10" r:id="rId32" imgW="1462151" imgH="1205798" progId="Prism10.Document">
                  <p:embed/>
                  <p:pic>
                    <p:nvPicPr>
                      <p:cNvPr id="102" name="Object 101">
                        <a:extLst>
                          <a:ext uri="{FF2B5EF4-FFF2-40B4-BE49-F238E27FC236}">
                            <a16:creationId xmlns:a16="http://schemas.microsoft.com/office/drawing/2014/main" id="{6B0D1598-284F-91CF-1A55-B637B7ACD2E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709840" y="6021341"/>
                        <a:ext cx="1462088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0" name="Object 109">
            <a:extLst>
              <a:ext uri="{FF2B5EF4-FFF2-40B4-BE49-F238E27FC236}">
                <a16:creationId xmlns:a16="http://schemas.microsoft.com/office/drawing/2014/main" id="{905CD738-9070-FE22-C2DE-923A837ACA9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3128618"/>
              </p:ext>
            </p:extLst>
          </p:nvPr>
        </p:nvGraphicFramePr>
        <p:xfrm>
          <a:off x="706668" y="7399164"/>
          <a:ext cx="1462088" cy="1206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4" imgW="1462151" imgH="1205798" progId="Prism10.Document">
                  <p:embed/>
                </p:oleObj>
              </mc:Choice>
              <mc:Fallback>
                <p:oleObj name="Prism 10" r:id="rId34" imgW="1462151" imgH="1205798" progId="Prism10.Document">
                  <p:embed/>
                  <p:pic>
                    <p:nvPicPr>
                      <p:cNvPr id="110" name="Object 109">
                        <a:extLst>
                          <a:ext uri="{FF2B5EF4-FFF2-40B4-BE49-F238E27FC236}">
                            <a16:creationId xmlns:a16="http://schemas.microsoft.com/office/drawing/2014/main" id="{804042DB-DB0B-8CA7-6630-9FB6CE0E03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706668" y="7399164"/>
                        <a:ext cx="1462088" cy="1206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6" name="Group 25">
            <a:extLst>
              <a:ext uri="{FF2B5EF4-FFF2-40B4-BE49-F238E27FC236}">
                <a16:creationId xmlns:a16="http://schemas.microsoft.com/office/drawing/2014/main" id="{7F799D88-BA39-7897-EEA3-7DDA7C3BD974}"/>
              </a:ext>
            </a:extLst>
          </p:cNvPr>
          <p:cNvGrpSpPr/>
          <p:nvPr/>
        </p:nvGrpSpPr>
        <p:grpSpPr>
          <a:xfrm>
            <a:off x="241716" y="837905"/>
            <a:ext cx="646331" cy="7503109"/>
            <a:chOff x="303499" y="837905"/>
            <a:chExt cx="646331" cy="7503109"/>
          </a:xfrm>
        </p:grpSpPr>
        <p:sp>
          <p:nvSpPr>
            <p:cNvPr id="12" name="TextBox 122">
              <a:extLst>
                <a:ext uri="{FF2B5EF4-FFF2-40B4-BE49-F238E27FC236}">
                  <a16:creationId xmlns:a16="http://schemas.microsoft.com/office/drawing/2014/main" id="{1C139171-2D45-B7BD-65B7-87213805B36A}"/>
                </a:ext>
              </a:extLst>
            </p:cNvPr>
            <p:cNvSpPr txBox="1"/>
            <p:nvPr/>
          </p:nvSpPr>
          <p:spPr>
            <a:xfrm rot="16200000">
              <a:off x="203152" y="938253"/>
              <a:ext cx="662361" cy="461665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>
                  <a:latin typeface="Arial"/>
                  <a:cs typeface="Arial"/>
                </a:rPr>
                <a:t>Chow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 (male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3">
              <a:extLst>
                <a:ext uri="{FF2B5EF4-FFF2-40B4-BE49-F238E27FC236}">
                  <a16:creationId xmlns:a16="http://schemas.microsoft.com/office/drawing/2014/main" id="{74010334-5A8C-8AB3-3B8C-71654DF3E834}"/>
                </a:ext>
              </a:extLst>
            </p:cNvPr>
            <p:cNvSpPr txBox="1"/>
            <p:nvPr/>
          </p:nvSpPr>
          <p:spPr>
            <a:xfrm rot="16200000">
              <a:off x="-22295" y="2338835"/>
              <a:ext cx="1113253" cy="461665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>
                  <a:latin typeface="Arial"/>
                  <a:cs typeface="Arial"/>
                </a:rPr>
                <a:t>Western Diet 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(male)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3">
              <a:extLst>
                <a:ext uri="{FF2B5EF4-FFF2-40B4-BE49-F238E27FC236}">
                  <a16:creationId xmlns:a16="http://schemas.microsoft.com/office/drawing/2014/main" id="{7476FED3-6C14-9CA0-7EF0-ADF11E285B26}"/>
                </a:ext>
              </a:extLst>
            </p:cNvPr>
            <p:cNvSpPr txBox="1"/>
            <p:nvPr/>
          </p:nvSpPr>
          <p:spPr>
            <a:xfrm rot="16200000">
              <a:off x="35798" y="3658525"/>
              <a:ext cx="1181734" cy="646331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dirty="0">
                  <a:latin typeface="Arial"/>
                  <a:cs typeface="Arial"/>
                </a:rPr>
                <a:t>W</a:t>
              </a:r>
              <a:r>
                <a:rPr lang="en-US" sz="1200" b="0" dirty="0">
                  <a:effectLst/>
                  <a:latin typeface="Arial"/>
                  <a:cs typeface="Arial"/>
                </a:rPr>
                <a:t>estern </a:t>
              </a:r>
              <a:r>
                <a:rPr lang="en-US" sz="1200" dirty="0">
                  <a:latin typeface="Arial"/>
                  <a:cs typeface="Arial"/>
                </a:rPr>
                <a:t>D</a:t>
              </a:r>
              <a:r>
                <a:rPr lang="en-US" sz="1200" b="0" dirty="0">
                  <a:effectLst/>
                  <a:latin typeface="Arial"/>
                  <a:cs typeface="Arial"/>
                </a:rPr>
                <a:t>iet</a:t>
              </a:r>
              <a:endParaRPr lang="de-DE" dirty="0">
                <a:latin typeface="Arial"/>
                <a:cs typeface="Arial"/>
              </a:endParaRP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Thermoneutral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(male)</a:t>
              </a:r>
            </a:p>
          </p:txBody>
        </p:sp>
        <p:sp>
          <p:nvSpPr>
            <p:cNvPr id="23" name="TextBox 4">
              <a:extLst>
                <a:ext uri="{FF2B5EF4-FFF2-40B4-BE49-F238E27FC236}">
                  <a16:creationId xmlns:a16="http://schemas.microsoft.com/office/drawing/2014/main" id="{E3C59D4F-2741-7324-DA74-C21FD86C6C13}"/>
                </a:ext>
              </a:extLst>
            </p:cNvPr>
            <p:cNvSpPr txBox="1"/>
            <p:nvPr/>
          </p:nvSpPr>
          <p:spPr>
            <a:xfrm rot="16200000">
              <a:off x="28424" y="5119818"/>
              <a:ext cx="1011815" cy="461665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0" dirty="0">
                  <a:effectLst/>
                  <a:latin typeface="Arial"/>
                  <a:cs typeface="Arial"/>
                </a:rPr>
                <a:t>High-fat diet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(male)</a:t>
              </a:r>
            </a:p>
          </p:txBody>
        </p:sp>
        <p:sp>
          <p:nvSpPr>
            <p:cNvPr id="24" name="TextBox 5">
              <a:extLst>
                <a:ext uri="{FF2B5EF4-FFF2-40B4-BE49-F238E27FC236}">
                  <a16:creationId xmlns:a16="http://schemas.microsoft.com/office/drawing/2014/main" id="{CACE87EA-B2AA-CAF5-88EA-9769811A81B9}"/>
                </a:ext>
              </a:extLst>
            </p:cNvPr>
            <p:cNvSpPr txBox="1"/>
            <p:nvPr/>
          </p:nvSpPr>
          <p:spPr>
            <a:xfrm rot="16200000">
              <a:off x="160672" y="6394935"/>
              <a:ext cx="747319" cy="461665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0" dirty="0">
                  <a:effectLst/>
                  <a:latin typeface="Arial"/>
                  <a:cs typeface="Arial"/>
                </a:rPr>
                <a:t>Chow</a:t>
              </a:r>
              <a:r>
                <a:rPr lang="en-US" sz="1200" dirty="0">
                  <a:latin typeface="Arial"/>
                  <a:cs typeface="Arial"/>
                </a:rPr>
                <a:t> 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(female)</a:t>
              </a:r>
              <a:endParaRPr lang="de-DE" dirty="0"/>
            </a:p>
          </p:txBody>
        </p:sp>
        <p:sp>
          <p:nvSpPr>
            <p:cNvPr id="25" name="TextBox 7">
              <a:extLst>
                <a:ext uri="{FF2B5EF4-FFF2-40B4-BE49-F238E27FC236}">
                  <a16:creationId xmlns:a16="http://schemas.microsoft.com/office/drawing/2014/main" id="{2D886CBF-BFAA-2E47-805D-35FCA336A757}"/>
                </a:ext>
              </a:extLst>
            </p:cNvPr>
            <p:cNvSpPr txBox="1"/>
            <p:nvPr/>
          </p:nvSpPr>
          <p:spPr>
            <a:xfrm rot="16200000">
              <a:off x="203151" y="7779001"/>
              <a:ext cx="662361" cy="461665"/>
            </a:xfrm>
            <a:prstGeom prst="rect">
              <a:avLst/>
            </a:prstGeom>
            <a:noFill/>
          </p:spPr>
          <p:txBody>
            <a:bodyPr wrap="none" lIns="91440" tIns="45720" rIns="91440" bIns="45720" rtlCol="0" anchor="t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200" b="0" dirty="0">
                  <a:effectLst/>
                  <a:latin typeface="Arial"/>
                  <a:cs typeface="Arial"/>
                </a:rPr>
                <a:t>Chow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 (male)</a:t>
              </a:r>
              <a:endParaRPr lang="de-DE" dirty="0"/>
            </a:p>
          </p:txBody>
        </p:sp>
      </p:grpSp>
      <p:grpSp>
        <p:nvGrpSpPr>
          <p:cNvPr id="27" name="Group 26">
            <a:extLst>
              <a:ext uri="{FF2B5EF4-FFF2-40B4-BE49-F238E27FC236}">
                <a16:creationId xmlns:a16="http://schemas.microsoft.com/office/drawing/2014/main" id="{ADC1C16D-5220-A55A-17D4-3C53790AC8FE}"/>
              </a:ext>
            </a:extLst>
          </p:cNvPr>
          <p:cNvGrpSpPr/>
          <p:nvPr/>
        </p:nvGrpSpPr>
        <p:grpSpPr>
          <a:xfrm>
            <a:off x="5554065" y="7952869"/>
            <a:ext cx="717884" cy="523219"/>
            <a:chOff x="5801715" y="8034149"/>
            <a:chExt cx="717884" cy="523219"/>
          </a:xfrm>
        </p:grpSpPr>
        <p:sp>
          <p:nvSpPr>
            <p:cNvPr id="19" name="TextBox 151">
              <a:extLst>
                <a:ext uri="{FF2B5EF4-FFF2-40B4-BE49-F238E27FC236}">
                  <a16:creationId xmlns:a16="http://schemas.microsoft.com/office/drawing/2014/main" id="{D41B4096-7C19-89E0-D181-A013DC2A276A}"/>
                </a:ext>
              </a:extLst>
            </p:cNvPr>
            <p:cNvSpPr txBox="1"/>
            <p:nvPr/>
          </p:nvSpPr>
          <p:spPr>
            <a:xfrm>
              <a:off x="5995296" y="8034149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</a:p>
          </p:txBody>
        </p:sp>
        <p:sp>
          <p:nvSpPr>
            <p:cNvPr id="20" name="TextBox 164">
              <a:extLst>
                <a:ext uri="{FF2B5EF4-FFF2-40B4-BE49-F238E27FC236}">
                  <a16:creationId xmlns:a16="http://schemas.microsoft.com/office/drawing/2014/main" id="{E2CF60F5-FDDA-81D0-3D56-FBAED453BF5E}"/>
                </a:ext>
              </a:extLst>
            </p:cNvPr>
            <p:cNvSpPr txBox="1"/>
            <p:nvPr/>
          </p:nvSpPr>
          <p:spPr>
            <a:xfrm>
              <a:off x="5990287" y="8295758"/>
              <a:ext cx="52931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L-KO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410BC92-1AE4-85BB-9B7A-7386374DE4B1}"/>
                </a:ext>
              </a:extLst>
            </p:cNvPr>
            <p:cNvSpPr/>
            <p:nvPr/>
          </p:nvSpPr>
          <p:spPr>
            <a:xfrm>
              <a:off x="5801715" y="8063779"/>
              <a:ext cx="194297" cy="20235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100"/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D9BD92C1-3A8A-E7BF-EEE4-9525715DE4D6}"/>
                </a:ext>
              </a:extLst>
            </p:cNvPr>
            <p:cNvSpPr/>
            <p:nvPr/>
          </p:nvSpPr>
          <p:spPr>
            <a:xfrm>
              <a:off x="5801715" y="8325388"/>
              <a:ext cx="194297" cy="202351"/>
            </a:xfrm>
            <a:prstGeom prst="rect">
              <a:avLst/>
            </a:prstGeom>
            <a:solidFill>
              <a:srgbClr val="8D8C8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 sz="1100"/>
            </a:p>
          </p:txBody>
        </p:sp>
      </p:grpSp>
    </p:spTree>
    <p:extLst>
      <p:ext uri="{BB962C8B-B14F-4D97-AF65-F5344CB8AC3E}">
        <p14:creationId xmlns:p14="http://schemas.microsoft.com/office/powerpoint/2010/main" val="459051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200" dirty="0" smtClean="0">
            <a:solidFill>
              <a:srgbClr val="FF0000"/>
            </a:solidFill>
            <a:highlight>
              <a:srgbClr val="FFFF00"/>
            </a:highlight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237</TotalTime>
  <Words>38</Words>
  <Application>Microsoft Office PowerPoint</Application>
  <PresentationFormat>Letter Paper (8.5x11 in)</PresentationFormat>
  <Paragraphs>2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GraphPad Prism Project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ulin regulates metabolism via zone-specific transcriptional programs</dc:title>
  <dc:creator>Biddinger Lab</dc:creator>
  <cp:lastModifiedBy>Mareike Schell</cp:lastModifiedBy>
  <cp:revision>959</cp:revision>
  <cp:lastPrinted>2025-04-30T14:37:08Z</cp:lastPrinted>
  <dcterms:created xsi:type="dcterms:W3CDTF">2022-04-06T00:07:38Z</dcterms:created>
  <dcterms:modified xsi:type="dcterms:W3CDTF">2025-07-09T01:26:33Z</dcterms:modified>
</cp:coreProperties>
</file>